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5" r:id="rId2"/>
    <p:sldId id="26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247"/>
    <p:restoredTop sz="81347"/>
  </p:normalViewPr>
  <p:slideViewPr>
    <p:cSldViewPr snapToGrid="0">
      <p:cViewPr varScale="1">
        <p:scale>
          <a:sx n="70" d="100"/>
          <a:sy n="70" d="100"/>
        </p:scale>
        <p:origin x="55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B63828-1F70-7143-9E85-845C458C7103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ACA806-A873-5B4A-95A9-AC7D458F2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9395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ure S1. </a:t>
            </a:r>
            <a:r>
              <a:rPr lang="en-US" sz="1800" b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histogram of the flow cytometry profiles monitoring cell cycle progression as determined by the distribution of DNA content. Two-way ANOVA analysis were performed, and treatments were compared to the DMSO control. Results are expressed as a percentage of total cells ± SD of three independent experiments in triplicate.</a:t>
            </a:r>
            <a:endParaRPr lang="en-US" sz="1800" b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ACA806-A873-5B4A-95A9-AC7D458F291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5469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</a:t>
            </a:r>
            <a:r>
              <a:rPr lang="en-US" b="1"/>
              <a:t>Figure S2</a:t>
            </a:r>
            <a:r>
              <a:rPr lang="en-US" b="1" dirty="0"/>
              <a:t>. </a:t>
            </a:r>
            <a:r>
              <a:rPr lang="en-US" b="0" dirty="0"/>
              <a:t>The Effect of </a:t>
            </a:r>
            <a:r>
              <a:rPr lang="en-US" sz="1800" b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patinib and Glyceollin Treatment on cell cycle regulator expression.  (a) The AC-1 and the LTLT-Ca cells were treated with the vehicle control (DMSO), 5 </a:t>
            </a:r>
            <a:r>
              <a:rPr lang="en-US" sz="1800" b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800" b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patinib, 10 </a:t>
            </a:r>
            <a:r>
              <a:rPr lang="en-US" sz="1800" b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800" b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lyceollin, and 5 </a:t>
            </a:r>
            <a:r>
              <a:rPr lang="en-US" sz="1800" b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800" b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patinib + 10 </a:t>
            </a:r>
            <a:r>
              <a:rPr lang="en-US" sz="1800" b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800" b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lyceollin for 24 h and assayed by immunoblot with antibodies directed against CDK2, p21, p27, and CDK1.  GAPDH  and B actin were measured as internal loading control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ACA806-A873-5B4A-95A9-AC7D458F291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7506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2B465-50FF-281F-27AA-AF3BA643F9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0D3A58-54BD-0CA4-FE25-18135EC6E5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5CBF4A-930C-47B8-251D-DE9F13114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DF285-21D1-0C13-4230-CA80D6EC3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EF9135-5FC1-5BED-F5F9-7A7DB21E7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239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7AE84-3B67-8DF9-2A1B-4B6555279F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794C8D-9B7A-044F-D7FB-AAE65520E4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5DD5B7-E2C9-BC6A-9965-81D009A1B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C81B78-8C3D-EB92-10A0-65EA2091F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641114-D120-D895-CD94-6C1A33778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782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BD81FE-C2EF-9B2A-F67F-80F71341DF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C14E63-E907-55D5-A064-14D9EC49C3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CF6FB-2CCE-F331-A236-8E54DFB70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C8E710-4B47-5D7A-8993-A1D6C1357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F97510-5A83-60A4-445C-4E4952B27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04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769F0A-5148-4AA9-5232-D59D7C44A6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0248F-F6AD-D2EE-F20A-377AC4C835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0957E1-6012-3D44-99BD-4D87C4A39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90528B-81FE-E9B6-5311-3E5674303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5F2ABA-C95E-218B-7E2F-CABD56E14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080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3B4F9-4F7E-EB81-79DA-9D5F50407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5DC29A-2AF0-716C-B830-D1CED1964C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AA628-6936-1CF6-AFFC-B3D186136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5113F6-B09D-A9D0-22B6-EDD3D4D5A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0E50E-A839-A734-466C-A401C9D42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106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97E848-43AA-0485-21C5-49F3D199C3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CFD510-2C87-0FAB-3608-36C544BCEA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0E88FD-9F45-78BF-1EA5-B76A0B189F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6778CA-B317-7A0A-8F76-A3AD2997A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8396FF-EE5C-E634-9596-714F533A9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999205-199E-216F-7C9F-D944250D9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78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5A713-4CC3-DC85-ACCF-BC32A8A5A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40795E-59FF-F629-B545-3757774EA5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9A0839-C9B7-3501-FB85-A0BDB552AE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2EBC6C-4E27-7F05-09B1-5C1AA6F0DF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BDE92D-72DD-83DF-0BDC-EFB54E596C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109BFE-CFDB-15FB-1D4C-F943B68D4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EDC3A9-0DA7-E955-138B-348E307E7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95B57F-A04B-7591-F6E4-AAD23EA56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203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3A6D7-A07B-B879-103D-A121DD8F95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847E0E-7781-8E47-F806-944697057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68D6B68-3AF1-FAC7-3633-879D3AE8D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39FC1F-34C8-B933-495E-5C6E139D24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515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127672-E0F9-CA80-0A01-16EC8307C6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B29FB9-1BF0-E308-8051-4B50EC60AA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9301D4-D180-30A8-E9D7-F8B610213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645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0FEF70-B8F0-5CA2-AA42-518137584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892AEB-6D82-B033-49F7-2041FF54E0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16CE9B-3EEC-B0C3-E9C9-18D8A7CC3A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052EB4-8A82-924A-B5CE-C235DB3C0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9D58CE-4DC8-F42B-DEDB-E5A7824CE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BE20AB-248A-CD9D-2696-1DACA3668C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500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45506A-17F4-06F5-C51A-BF579A9C2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AE577B-2BDA-F0FD-DE42-5A2CAEEB63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464046-C465-25D6-8C97-657F842DC2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D0A5C6-698B-CC3D-1E04-B625FC35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32FD1F-E211-B984-57B0-6D44D6BD2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DE232C-2D11-6008-5578-4D58BDA6A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635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82CEF5-E2FA-D657-DF37-6349DC08CE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B742BB-63EB-9F1F-5D87-8877FEEDFC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19DEEC-6BD1-51DC-8AD3-BC9A8967DE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BCCBF-519D-3540-B5FA-D4EDB09798BD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7AF198-5A61-E485-74CD-A15B619E24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954D9B-2DB5-63D4-43E1-02936A6D82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DB12D-362B-6A42-B48E-37AF0E32E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56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A2CD180-D887-6D75-FDBD-CF68C39E00F7}"/>
              </a:ext>
            </a:extLst>
          </p:cNvPr>
          <p:cNvGrpSpPr/>
          <p:nvPr/>
        </p:nvGrpSpPr>
        <p:grpSpPr>
          <a:xfrm>
            <a:off x="-105178" y="407830"/>
            <a:ext cx="12402355" cy="5709633"/>
            <a:chOff x="-447232" y="1219200"/>
            <a:chExt cx="9667432" cy="337621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73B46CF-E4FB-668B-6DA1-6BFA1F93BF62}"/>
                </a:ext>
              </a:extLst>
            </p:cNvPr>
            <p:cNvGrpSpPr/>
            <p:nvPr/>
          </p:nvGrpSpPr>
          <p:grpSpPr>
            <a:xfrm>
              <a:off x="-34312" y="1219200"/>
              <a:ext cx="9254512" cy="3352800"/>
              <a:chOff x="-34312" y="1219200"/>
              <a:chExt cx="9254512" cy="3352800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5CE7C261-5560-FA6D-3974-2561FD303C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928101" y="3258951"/>
                <a:ext cx="2292099" cy="127032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F275533-881E-C72A-D213-661A7B4705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607548" y="3216223"/>
                <a:ext cx="2326652" cy="1355777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15D54615-69FC-3C0B-0BAB-5B7DD56E34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86000" y="3200400"/>
                <a:ext cx="2267597" cy="131165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7BD73DFB-8231-4D3C-26D3-3D3C2BD936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34312" y="3222312"/>
                <a:ext cx="2320312" cy="1288429"/>
              </a:xfrm>
              <a:prstGeom prst="rect">
                <a:avLst/>
              </a:prstGeom>
            </p:spPr>
          </p:pic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EABED8DA-D13F-7026-12A7-2B7878924939}"/>
                  </a:ext>
                </a:extLst>
              </p:cNvPr>
              <p:cNvGrpSpPr/>
              <p:nvPr/>
            </p:nvGrpSpPr>
            <p:grpSpPr>
              <a:xfrm>
                <a:off x="-21846" y="1219200"/>
                <a:ext cx="9192676" cy="1760738"/>
                <a:chOff x="-21846" y="304800"/>
                <a:chExt cx="9192676" cy="1760738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8089A1C5-73E9-AF22-B4D9-75763368ECE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-21846" y="689718"/>
                  <a:ext cx="2324100" cy="1367681"/>
                </a:xfrm>
                <a:prstGeom prst="rect">
                  <a:avLst/>
                </a:prstGeom>
              </p:spPr>
            </p:pic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7461FB41-ED4F-5FF6-A01A-1A045ACE06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286000" y="709813"/>
                  <a:ext cx="2324100" cy="1355725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82346BE1-C9B3-DEC2-0E53-A9673C7C812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4648200" y="762000"/>
                  <a:ext cx="2173892" cy="1270318"/>
                </a:xfrm>
                <a:prstGeom prst="rect">
                  <a:avLst/>
                </a:prstGeom>
              </p:spPr>
            </p:pic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68FB9955-E640-BC5D-26BA-0F17355A47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6934200" y="762000"/>
                  <a:ext cx="2236630" cy="1270319"/>
                </a:xfrm>
                <a:prstGeom prst="rect">
                  <a:avLst/>
                </a:prstGeom>
              </p:spPr>
            </p:pic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63F0B55B-62FE-7CFA-797A-B44C78020ADD}"/>
                    </a:ext>
                  </a:extLst>
                </p:cNvPr>
                <p:cNvSpPr txBox="1"/>
                <p:nvPr/>
              </p:nvSpPr>
              <p:spPr>
                <a:xfrm>
                  <a:off x="916141" y="309430"/>
                  <a:ext cx="60785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DAA3FA5A-D92F-B124-4DC4-2528B5AA71DE}"/>
                    </a:ext>
                  </a:extLst>
                </p:cNvPr>
                <p:cNvSpPr txBox="1"/>
                <p:nvPr/>
              </p:nvSpPr>
              <p:spPr>
                <a:xfrm>
                  <a:off x="3331831" y="309430"/>
                  <a:ext cx="5693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p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DDD0A6F-C0FD-D4AC-D75C-9F5280CFE7A1}"/>
                    </a:ext>
                  </a:extLst>
                </p:cNvPr>
                <p:cNvSpPr txBox="1"/>
                <p:nvPr/>
              </p:nvSpPr>
              <p:spPr>
                <a:xfrm>
                  <a:off x="5703233" y="304800"/>
                  <a:ext cx="53091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ly</a:t>
                  </a:r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7E9CCCF8-6EDC-DCBD-6E6B-8E08C94E0FA0}"/>
                    </a:ext>
                  </a:extLst>
                </p:cNvPr>
                <p:cNvSpPr txBox="1"/>
                <p:nvPr/>
              </p:nvSpPr>
              <p:spPr>
                <a:xfrm>
                  <a:off x="7467600" y="304800"/>
                  <a:ext cx="117852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p + </a:t>
                  </a:r>
                  <a:r>
                    <a:rPr lang="en-US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ly</a:t>
                  </a:r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057609D-7437-FA7F-A42B-65DDEC4790A8}"/>
                </a:ext>
              </a:extLst>
            </p:cNvPr>
            <p:cNvSpPr txBox="1"/>
            <p:nvPr/>
          </p:nvSpPr>
          <p:spPr>
            <a:xfrm rot="16200000">
              <a:off x="-906332" y="2048906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-1 Cells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507CF6B-0C6E-C02A-5CAA-5B8E61F22EF0}"/>
                </a:ext>
              </a:extLst>
            </p:cNvPr>
            <p:cNvSpPr txBox="1"/>
            <p:nvPr/>
          </p:nvSpPr>
          <p:spPr>
            <a:xfrm rot="16200000">
              <a:off x="-1075191" y="3598120"/>
              <a:ext cx="16252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LTLT-Ca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906978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id="{9815B961-B6C2-4C8B-2644-645D88A1DABB}"/>
              </a:ext>
            </a:extLst>
          </p:cNvPr>
          <p:cNvGrpSpPr/>
          <p:nvPr/>
        </p:nvGrpSpPr>
        <p:grpSpPr>
          <a:xfrm>
            <a:off x="1470104" y="1219395"/>
            <a:ext cx="7001101" cy="4256350"/>
            <a:chOff x="1470104" y="1219395"/>
            <a:chExt cx="7001101" cy="425635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401623D-9EF0-7C3C-BBA1-B08F6C788F97}"/>
                </a:ext>
              </a:extLst>
            </p:cNvPr>
            <p:cNvSpPr txBox="1"/>
            <p:nvPr/>
          </p:nvSpPr>
          <p:spPr>
            <a:xfrm>
              <a:off x="1497429" y="4418608"/>
              <a:ext cx="1027296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DK1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47635967-5875-2F01-6FC7-04ACCFA7FB66}"/>
                </a:ext>
              </a:extLst>
            </p:cNvPr>
            <p:cNvGrpSpPr/>
            <p:nvPr/>
          </p:nvGrpSpPr>
          <p:grpSpPr>
            <a:xfrm>
              <a:off x="2825219" y="4386535"/>
              <a:ext cx="5309235" cy="464196"/>
              <a:chOff x="2877977" y="4982348"/>
              <a:chExt cx="5309235" cy="464196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20899C7-F7F9-2275-5846-805460F07B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877977" y="4999062"/>
                <a:ext cx="2428875" cy="40005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01046E0D-85CB-4098-CDDD-A83E7EE0CA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615462" y="4982348"/>
                <a:ext cx="2571750" cy="464196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08B904DF-9A2D-76DF-A884-BE0FAEA4DB88}"/>
                </a:ext>
              </a:extLst>
            </p:cNvPr>
            <p:cNvGrpSpPr/>
            <p:nvPr/>
          </p:nvGrpSpPr>
          <p:grpSpPr>
            <a:xfrm>
              <a:off x="2823523" y="4961395"/>
              <a:ext cx="5358239" cy="514350"/>
              <a:chOff x="2877977" y="5770670"/>
              <a:chExt cx="5358239" cy="514350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FAFECD42-AB28-BBD8-C935-9CF7288920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877977" y="5770670"/>
                <a:ext cx="2443048" cy="51435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CA9724DC-B244-2CFE-3F1A-09EFCB904C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615462" y="5808770"/>
                <a:ext cx="2620754" cy="438150"/>
              </a:xfrm>
              <a:prstGeom prst="rect">
                <a:avLst/>
              </a:prstGeom>
              <a:ln>
                <a:noFill/>
              </a:ln>
            </p:spPr>
          </p:pic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D9D076-C471-0E43-2BEE-8E7040F68C0D}"/>
                </a:ext>
              </a:extLst>
            </p:cNvPr>
            <p:cNvSpPr txBox="1"/>
            <p:nvPr/>
          </p:nvSpPr>
          <p:spPr>
            <a:xfrm>
              <a:off x="1470104" y="4962080"/>
              <a:ext cx="1027296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 Actin</a:t>
              </a:r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2273B79E-2461-412E-8401-9ADB1CBBCF50}"/>
                </a:ext>
              </a:extLst>
            </p:cNvPr>
            <p:cNvGrpSpPr/>
            <p:nvPr/>
          </p:nvGrpSpPr>
          <p:grpSpPr>
            <a:xfrm>
              <a:off x="1497429" y="1219395"/>
              <a:ext cx="6973776" cy="2957442"/>
              <a:chOff x="1497429" y="1219395"/>
              <a:chExt cx="6973776" cy="2957442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3156C5D2-ED19-9F79-7CD9-FB13BC59ED54}"/>
                  </a:ext>
                </a:extLst>
              </p:cNvPr>
              <p:cNvGrpSpPr/>
              <p:nvPr/>
            </p:nvGrpSpPr>
            <p:grpSpPr>
              <a:xfrm>
                <a:off x="1497429" y="3706421"/>
                <a:ext cx="6485149" cy="470416"/>
                <a:chOff x="1469719" y="1997895"/>
                <a:chExt cx="6485149" cy="470416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788A637F-3138-CC5A-92BE-7608C1BC2E3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2961811" y="1997895"/>
                  <a:ext cx="4993057" cy="470416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229A680A-9C28-B74F-0E2E-3528F658BF59}"/>
                    </a:ext>
                  </a:extLst>
                </p:cNvPr>
                <p:cNvSpPr txBox="1"/>
                <p:nvPr/>
              </p:nvSpPr>
              <p:spPr>
                <a:xfrm>
                  <a:off x="1469719" y="2016069"/>
                  <a:ext cx="1027296" cy="3693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</a:p>
              </p:txBody>
            </p:sp>
          </p:grp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ECA55F2B-1F46-0FE9-D225-C4CE85CDC9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987039" y="2412482"/>
                <a:ext cx="5229225" cy="447675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8405517-E21E-56A6-C6B7-6D193262E362}"/>
                  </a:ext>
                </a:extLst>
              </p:cNvPr>
              <p:cNvSpPr txBox="1"/>
              <p:nvPr/>
            </p:nvSpPr>
            <p:spPr>
              <a:xfrm>
                <a:off x="1608268" y="2476691"/>
                <a:ext cx="961099" cy="3834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CDK2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4010DECD-A81D-38C9-9CA0-BCE722D320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904357" y="2864575"/>
                <a:ext cx="5150960" cy="40005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72477C8-7505-A417-993A-C39ADA5719DA}"/>
                  </a:ext>
                </a:extLst>
              </p:cNvPr>
              <p:cNvSpPr txBox="1"/>
              <p:nvPr/>
            </p:nvSpPr>
            <p:spPr>
              <a:xfrm>
                <a:off x="1707635" y="2883863"/>
                <a:ext cx="958717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p21</a:t>
                </a:r>
              </a:p>
            </p:txBody>
          </p:sp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F6AB2B89-A3A6-6E6C-0C94-5443AF6525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904357" y="3148012"/>
                <a:ext cx="5162550" cy="561975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BE2FEC6-A2A8-80E8-3498-5B5EB937C4BD}"/>
                  </a:ext>
                </a:extLst>
              </p:cNvPr>
              <p:cNvSpPr txBox="1"/>
              <p:nvPr/>
            </p:nvSpPr>
            <p:spPr>
              <a:xfrm>
                <a:off x="1691398" y="3330278"/>
                <a:ext cx="961099" cy="3834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p27</a:t>
                </a:r>
              </a:p>
            </p:txBody>
          </p: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48C2BC1E-D28A-9B0B-B62E-E47D9E823381}"/>
                  </a:ext>
                </a:extLst>
              </p:cNvPr>
              <p:cNvGrpSpPr/>
              <p:nvPr/>
            </p:nvGrpSpPr>
            <p:grpSpPr>
              <a:xfrm>
                <a:off x="2928375" y="1219395"/>
                <a:ext cx="5542830" cy="1064405"/>
                <a:chOff x="2928375" y="692917"/>
                <a:chExt cx="5542830" cy="1064405"/>
              </a:xfrm>
            </p:grpSpPr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4241F3B5-DDCE-9D4E-0F47-4E0716D2FF79}"/>
                    </a:ext>
                  </a:extLst>
                </p:cNvPr>
                <p:cNvSpPr txBox="1"/>
                <p:nvPr/>
              </p:nvSpPr>
              <p:spPr>
                <a:xfrm>
                  <a:off x="3763185" y="692917"/>
                  <a:ext cx="71045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-1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164E75B2-D273-3798-6226-94C1275D8510}"/>
                    </a:ext>
                  </a:extLst>
                </p:cNvPr>
                <p:cNvSpPr txBox="1"/>
                <p:nvPr/>
              </p:nvSpPr>
              <p:spPr>
                <a:xfrm rot="18996547">
                  <a:off x="2935251" y="1389825"/>
                  <a:ext cx="72327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A77454EF-FFB3-ED61-8A6A-77BFAFD5A21D}"/>
                    </a:ext>
                  </a:extLst>
                </p:cNvPr>
                <p:cNvSpPr txBox="1"/>
                <p:nvPr/>
              </p:nvSpPr>
              <p:spPr>
                <a:xfrm rot="18996547">
                  <a:off x="3656864" y="1407664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p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DCCD7435-028D-3D96-AA50-AC994D70966E}"/>
                    </a:ext>
                  </a:extLst>
                </p:cNvPr>
                <p:cNvSpPr txBox="1"/>
                <p:nvPr/>
              </p:nvSpPr>
              <p:spPr>
                <a:xfrm rot="18996547">
                  <a:off x="4162090" y="1447588"/>
                  <a:ext cx="45397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ly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938F2EE-E2AD-DC0E-A124-5EB9CDBD31E5}"/>
                    </a:ext>
                  </a:extLst>
                </p:cNvPr>
                <p:cNvSpPr txBox="1"/>
                <p:nvPr/>
              </p:nvSpPr>
              <p:spPr>
                <a:xfrm rot="18996547">
                  <a:off x="4619879" y="1299994"/>
                  <a:ext cx="955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p + </a:t>
                  </a:r>
                  <a:r>
                    <a:rPr lang="en-US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ly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DB4C7A2B-95FC-0B8E-E1BE-DFA5751181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28375" y="1062249"/>
                  <a:ext cx="2368405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725E1990-4583-35DC-64FD-2BED66885ACE}"/>
                    </a:ext>
                  </a:extLst>
                </p:cNvPr>
                <p:cNvSpPr txBox="1"/>
                <p:nvPr/>
              </p:nvSpPr>
              <p:spPr>
                <a:xfrm>
                  <a:off x="6658800" y="694874"/>
                  <a:ext cx="104817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TLT-Ca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8985E4D7-6BA8-CC82-96D9-FB8D9870EB16}"/>
                    </a:ext>
                  </a:extLst>
                </p:cNvPr>
                <p:cNvSpPr txBox="1"/>
                <p:nvPr/>
              </p:nvSpPr>
              <p:spPr>
                <a:xfrm rot="18996547">
                  <a:off x="5830866" y="1391782"/>
                  <a:ext cx="72327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D8070351-30AD-9B6C-3DC1-1623EAD19AB2}"/>
                    </a:ext>
                  </a:extLst>
                </p:cNvPr>
                <p:cNvSpPr txBox="1"/>
                <p:nvPr/>
              </p:nvSpPr>
              <p:spPr>
                <a:xfrm rot="18996547">
                  <a:off x="6552479" y="1409621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p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BADCF0EC-8F25-B353-C232-BA6D3C1F637D}"/>
                    </a:ext>
                  </a:extLst>
                </p:cNvPr>
                <p:cNvSpPr txBox="1"/>
                <p:nvPr/>
              </p:nvSpPr>
              <p:spPr>
                <a:xfrm rot="18996547">
                  <a:off x="7057705" y="1449545"/>
                  <a:ext cx="45397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ly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7649887B-A508-AAC0-4E0D-2693E4A58BEB}"/>
                    </a:ext>
                  </a:extLst>
                </p:cNvPr>
                <p:cNvSpPr txBox="1"/>
                <p:nvPr/>
              </p:nvSpPr>
              <p:spPr>
                <a:xfrm rot="18996547">
                  <a:off x="7515494" y="1301951"/>
                  <a:ext cx="955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p + </a:t>
                  </a:r>
                  <a:r>
                    <a:rPr lang="en-US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ly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FEA3F987-31EE-2CF9-25E6-D9135860703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23990" y="1064206"/>
                  <a:ext cx="2368405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3468682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6</TotalTime>
  <Words>173</Words>
  <Application>Microsoft Office PowerPoint</Application>
  <PresentationFormat>Widescreen</PresentationFormat>
  <Paragraphs>2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lghman, Syreeta</dc:creator>
  <cp:lastModifiedBy>MDPI</cp:lastModifiedBy>
  <cp:revision>7</cp:revision>
  <dcterms:created xsi:type="dcterms:W3CDTF">2022-12-28T21:13:51Z</dcterms:created>
  <dcterms:modified xsi:type="dcterms:W3CDTF">2023-03-28T04:57:03Z</dcterms:modified>
</cp:coreProperties>
</file>